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914FE-2C06-4B14-AA53-563CE95ECD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553B7-9427-4CB2-A508-4774E9CF5A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78190-4781-4B06-8543-E6A04CBF11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93E71-ED01-481B-AB56-EC5A92996B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8A759-0134-4F45-A4A5-46E576B165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F576A-17F9-4207-A6A0-FE137A48B6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F6A4D-080F-4A80-AB4E-33F93E90A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4C3A4-1A26-436C-B856-DA836C986A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9C565-6CD2-4F77-8338-15346EA688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E0E68-41E2-445E-815F-658DAE005C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1D366-060D-4CDF-A9DC-2FAB574536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37132-9B90-4B19-B7A0-6A740D1608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5B2A9C-9DF7-403C-BDB2-95A6593DD2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4920" y="990720"/>
          <a:ext cx="8686800" cy="3305160"/>
        </p:xfrm>
        <a:graphic>
          <a:graphicData uri="http://schemas.openxmlformats.org/drawingml/2006/table">
            <a:tbl>
              <a:tblPr/>
              <a:tblGrid>
                <a:gridCol w="1541520"/>
                <a:gridCol w="1035000"/>
                <a:gridCol w="1035000"/>
                <a:gridCol w="1085760"/>
                <a:gridCol w="1163520"/>
                <a:gridCol w="941400"/>
                <a:gridCol w="943200"/>
                <a:gridCol w="941400"/>
              </a:tblGrid>
              <a:tr h="40068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Vill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pu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 rate 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Dongson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6,8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imhw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,4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Se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,9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alm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3,6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eunna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,6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.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2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3,4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12"/>
          <p:cNvSpPr/>
          <p:nvPr/>
        </p:nvSpPr>
        <p:spPr>
          <a:xfrm>
            <a:off x="380880" y="457200"/>
            <a:ext cx="6858000" cy="41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. Positive rate of fluorescent antibody responses of sera in Cheorwon surveyed ar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4"/>
          <p:cNvSpPr/>
          <p:nvPr/>
        </p:nvSpPr>
        <p:spPr>
          <a:xfrm>
            <a:off x="1066680" y="4419720"/>
            <a:ext cx="754380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 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* Significant between AAPI and positive rate of IFAT was analyzed by Two-way ANOVA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0033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#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positive rate of IFAT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6485, 2006;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=  0.6012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&amp;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AAPI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3234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 0.3330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9:14Z</dcterms:created>
  <dc:creator>Lee</dc:creator>
  <dc:description/>
  <dc:language>en-US</dc:language>
  <cp:lastModifiedBy>Marcel Hommel</cp:lastModifiedBy>
  <dcterms:modified xsi:type="dcterms:W3CDTF">2012-07-22T10:30:34Z</dcterms:modified>
  <cp:revision>3</cp:revision>
  <dc:subject/>
  <dc:title>Slide 1</dc:title>
</cp:coreProperties>
</file>